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99200" cy="10234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76560" cy="509760"/>
          </a:xfrm>
          <a:prstGeom prst="rect">
            <a:avLst/>
          </a:prstGeom>
          <a:noFill/>
          <a:ln w="0">
            <a:noFill/>
          </a:ln>
        </p:spPr>
        <p:txBody>
          <a:bodyPr lIns="98280" rIns="98280" tIns="49320" bIns="493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021200" y="0"/>
            <a:ext cx="3076560" cy="509760"/>
          </a:xfrm>
          <a:prstGeom prst="rect">
            <a:avLst/>
          </a:prstGeom>
          <a:noFill/>
          <a:ln w="0">
            <a:noFill/>
          </a:ln>
        </p:spPr>
        <p:txBody>
          <a:bodyPr lIns="98280" rIns="98280" tIns="49320" bIns="4932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82800"/>
                <a:tab algn="l" pos="1965240"/>
                <a:tab algn="l" pos="2948040"/>
                <a:tab algn="l" pos="3930480"/>
                <a:tab algn="l" pos="4913280"/>
                <a:tab algn="l" pos="5896080"/>
                <a:tab algn="l" pos="6878520"/>
                <a:tab algn="l" pos="7861320"/>
                <a:tab algn="l" pos="8844120"/>
                <a:tab algn="l" pos="9826560"/>
                <a:tab algn="l" pos="10809360"/>
              </a:tabLst>
              <a:defRPr b="0" lang="en-US" sz="13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82800"/>
                <a:tab algn="l" pos="1965240"/>
                <a:tab algn="l" pos="2948040"/>
                <a:tab algn="l" pos="3930480"/>
                <a:tab algn="l" pos="4913280"/>
                <a:tab algn="l" pos="5896080"/>
                <a:tab algn="l" pos="6878520"/>
                <a:tab algn="l" pos="7861320"/>
                <a:tab algn="l" pos="8844120"/>
                <a:tab algn="l" pos="9826560"/>
                <a:tab algn="l" pos="1080936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11400" y="767880"/>
            <a:ext cx="2876400" cy="3837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101520" rIns="101520" tIns="50760" bIns="507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98280" rIns="98280" tIns="49320" bIns="4932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723240"/>
            <a:ext cx="3076560" cy="509400"/>
          </a:xfrm>
          <a:prstGeom prst="rect">
            <a:avLst/>
          </a:prstGeom>
          <a:noFill/>
          <a:ln w="0">
            <a:noFill/>
          </a:ln>
        </p:spPr>
        <p:txBody>
          <a:bodyPr lIns="98280" rIns="98280" tIns="49320" bIns="4932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021200" y="9723240"/>
            <a:ext cx="3076560" cy="509400"/>
          </a:xfrm>
          <a:prstGeom prst="rect">
            <a:avLst/>
          </a:prstGeom>
          <a:noFill/>
          <a:ln w="0">
            <a:noFill/>
          </a:ln>
        </p:spPr>
        <p:txBody>
          <a:bodyPr lIns="98280" rIns="98280" tIns="49320" bIns="4932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82800"/>
                <a:tab algn="l" pos="1965240"/>
                <a:tab algn="l" pos="2948040"/>
                <a:tab algn="l" pos="3930480"/>
                <a:tab algn="l" pos="4913280"/>
                <a:tab algn="l" pos="5896080"/>
                <a:tab algn="l" pos="6878520"/>
                <a:tab algn="l" pos="7861320"/>
                <a:tab algn="l" pos="8844120"/>
                <a:tab algn="l" pos="9826560"/>
                <a:tab algn="l" pos="10809360"/>
              </a:tabLst>
              <a:defRPr b="0" lang="en-US" sz="13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82800"/>
                <a:tab algn="l" pos="1965240"/>
                <a:tab algn="l" pos="2948040"/>
                <a:tab algn="l" pos="3930480"/>
                <a:tab algn="l" pos="4913280"/>
                <a:tab algn="l" pos="5896080"/>
                <a:tab algn="l" pos="6878520"/>
                <a:tab algn="l" pos="7861320"/>
                <a:tab algn="l" pos="8844120"/>
                <a:tab algn="l" pos="9826560"/>
                <a:tab algn="l" pos="10809360"/>
              </a:tabLst>
            </a:pPr>
            <a:fld id="{EAB93E1C-E23A-4209-819A-A1A26BFEE6BE}" type="slidenum">
              <a:rPr b="0" lang="en-US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sldImg"/>
          </p:nvPr>
        </p:nvSpPr>
        <p:spPr>
          <a:xfrm>
            <a:off x="2111400" y="768240"/>
            <a:ext cx="2876400" cy="3837240"/>
          </a:xfrm>
          <a:prstGeom prst="rect">
            <a:avLst/>
          </a:prstGeom>
          <a:ln w="0">
            <a:noFill/>
          </a:ln>
        </p:spPr>
      </p:sp>
      <p:sp>
        <p:nvSpPr>
          <p:cNvPr id="60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Slide Number Placeholder 3"/>
          <p:cNvSpPr/>
          <p:nvPr/>
        </p:nvSpPr>
        <p:spPr>
          <a:xfrm>
            <a:off x="4021200" y="9723600"/>
            <a:ext cx="3076560" cy="509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8280" rIns="98280" tIns="49320" bIns="4932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82800"/>
                <a:tab algn="l" pos="1965240"/>
                <a:tab algn="l" pos="2948040"/>
                <a:tab algn="l" pos="3930480"/>
                <a:tab algn="l" pos="4913280"/>
                <a:tab algn="l" pos="5896080"/>
                <a:tab algn="l" pos="6878520"/>
                <a:tab algn="l" pos="7861320"/>
                <a:tab algn="l" pos="8844120"/>
                <a:tab algn="l" pos="9826560"/>
                <a:tab algn="l" pos="10809360"/>
              </a:tabLst>
            </a:pPr>
            <a:fld id="{4715CA4C-3C35-43E7-919F-364F0F522BC9}" type="slidenum">
              <a:rPr b="0" lang="en-US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0BFCF5-CD4B-41FD-8D11-4BCD5489FCC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5EBBAA-1827-4664-B5B8-63F9055D288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37497F-CE4C-49FD-95AE-1EFCE37902C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CC93EA-5C27-4125-B0A3-278258B0316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1C7EFB-5690-4696-B5CA-FD6A306DD98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679346-851E-42B8-9EA4-F0D31C766B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6E82DF-F06F-4334-86BF-E0B7292659B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58F67F-1224-4D5A-9A98-2C75678031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670357-AFAD-4CAD-93CD-E0FBAACAFF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14DDBB-3A9C-41EE-B75F-15C998688C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A72DEC-A892-4BF9-8CC9-D8590AF3E3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CA4A88-A76C-4E59-BE05-EB96FE0243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3F93F70-02CC-4CE8-B8A5-5C2F84F4F02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57"/>
          <p:cNvSpPr/>
          <p:nvPr/>
        </p:nvSpPr>
        <p:spPr>
          <a:xfrm>
            <a:off x="-27000" y="4191120"/>
            <a:ext cx="6716880" cy="46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Supplemental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able S3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rimers used for infusion cloning of IRF3 promoter into the pGL3 basic vector, mutagenesis and sequencing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9" name=""/>
          <p:cNvGraphicFramePr/>
          <p:nvPr/>
        </p:nvGraphicFramePr>
        <p:xfrm>
          <a:off x="66600" y="4800600"/>
          <a:ext cx="6248520" cy="2355840"/>
        </p:xfrm>
        <a:graphic>
          <a:graphicData uri="http://schemas.openxmlformats.org/drawingml/2006/table">
            <a:tbl>
              <a:tblPr/>
              <a:tblGrid>
                <a:gridCol w="2154240"/>
                <a:gridCol w="4094280"/>
              </a:tblGrid>
              <a:tr h="2667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358920"/>
                          <a:tab algn="l" pos="719280"/>
                          <a:tab algn="l" pos="1079640"/>
                          <a:tab algn="l" pos="1438200"/>
                          <a:tab algn="l" pos="1798560"/>
                          <a:tab algn="l" pos="2158920"/>
                          <a:tab algn="l" pos="2519280"/>
                          <a:tab algn="l" pos="2879640"/>
                          <a:tab algn="l" pos="3238560"/>
                          <a:tab algn="l" pos="3598920"/>
                          <a:tab algn="l" pos="3959280"/>
                          <a:tab algn="l" pos="431964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rimer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equence (5' to 3'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676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358920"/>
                          <a:tab algn="l" pos="719280"/>
                          <a:tab algn="l" pos="1079640"/>
                          <a:tab algn="l" pos="1438200"/>
                          <a:tab algn="l" pos="1798560"/>
                          <a:tab algn="l" pos="2158920"/>
                          <a:tab algn="l" pos="2519280"/>
                          <a:tab algn="l" pos="2879640"/>
                          <a:tab algn="l" pos="3238560"/>
                          <a:tab algn="l" pos="3598920"/>
                          <a:tab algn="l" pos="3959280"/>
                          <a:tab algn="l" pos="431964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' Infusion pgl3 Nhe IRF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358920"/>
                          <a:tab algn="l" pos="719280"/>
                          <a:tab algn="l" pos="1079640"/>
                          <a:tab algn="l" pos="1438200"/>
                          <a:tab algn="l" pos="1798560"/>
                          <a:tab algn="l" pos="2158920"/>
                          <a:tab algn="l" pos="2519280"/>
                          <a:tab algn="l" pos="2879640"/>
                          <a:tab algn="l" pos="3238560"/>
                          <a:tab algn="l" pos="3598920"/>
                          <a:tab algn="l" pos="3959280"/>
                          <a:tab algn="l" pos="431964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CTTACGCGT</a:t>
                      </a:r>
                      <a:r>
                        <a:rPr b="0" lang="sv-SE" sz="1000" spc="-1" strike="noStrike" u="sng">
                          <a:solidFill>
                            <a:srgbClr val="000000"/>
                          </a:solidFill>
                          <a:uFillTx/>
                          <a:latin typeface="Arial"/>
                          <a:ea typeface="Times New Roman"/>
                        </a:rPr>
                        <a:t>GCTAGC</a:t>
                      </a:r>
                      <a:r>
                        <a:rPr b="0" lang="sv-S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GTCAACACCCCGCTGACCT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44440"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' Infusion pgl3 Ncoi IRF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TGGCGTCTTCCATGGGGTCCGGCCTGCGCGTATAGG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6760">
                <a:tc rowSpan="4"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rimers for mutagenesi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358920"/>
                          <a:tab algn="l" pos="719280"/>
                          <a:tab algn="l" pos="1079640"/>
                          <a:tab algn="l" pos="1438200"/>
                          <a:tab algn="l" pos="1798560"/>
                          <a:tab algn="l" pos="2158920"/>
                          <a:tab algn="l" pos="2519280"/>
                          <a:tab algn="l" pos="2879640"/>
                          <a:tab algn="l" pos="3238560"/>
                          <a:tab algn="l" pos="3598920"/>
                          <a:tab algn="l" pos="3959280"/>
                          <a:tab algn="l" pos="431964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</a:t>
                      </a:r>
                      <a:r>
                        <a:rPr b="0" lang="sv-S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-925 A: CAAGAAGTCGATC</a:t>
                      </a:r>
                      <a:r>
                        <a:rPr b="1" lang="sv-S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</a:t>
                      </a:r>
                      <a:r>
                        <a:rPr b="0" lang="sv-S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AAAGAAAGCCCCAG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6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358920"/>
                          <a:tab algn="l" pos="719280"/>
                          <a:tab algn="l" pos="1079640"/>
                          <a:tab algn="l" pos="1438200"/>
                          <a:tab algn="l" pos="1798560"/>
                          <a:tab algn="l" pos="2158920"/>
                          <a:tab algn="l" pos="2519280"/>
                          <a:tab algn="l" pos="2879640"/>
                          <a:tab algn="l" pos="3238560"/>
                          <a:tab algn="l" pos="3598920"/>
                          <a:tab algn="l" pos="3959280"/>
                          <a:tab algn="l" pos="431964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-925 G: CAAGAAGTCGATC</a:t>
                      </a:r>
                      <a:r>
                        <a:rPr b="1" lang="sv-S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G</a:t>
                      </a:r>
                      <a:r>
                        <a:rPr b="0" lang="sv-S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AAAGAAAGCCCCAG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67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358920"/>
                          <a:tab algn="l" pos="719280"/>
                          <a:tab algn="l" pos="1079640"/>
                          <a:tab algn="l" pos="1438200"/>
                          <a:tab algn="l" pos="1798560"/>
                          <a:tab algn="l" pos="2158920"/>
                          <a:tab algn="l" pos="2519280"/>
                          <a:tab algn="l" pos="2879640"/>
                          <a:tab algn="l" pos="3238560"/>
                          <a:tab algn="l" pos="3598920"/>
                          <a:tab algn="l" pos="3959280"/>
                          <a:tab algn="l" pos="431964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-776 C: CGCGGAAGAGCC</a:t>
                      </a:r>
                      <a:r>
                        <a:rPr b="1" lang="sv-S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</a:t>
                      </a:r>
                      <a:r>
                        <a:rPr b="0" lang="sv-S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GGGAGAGCGTTGGTGG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67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358920"/>
                          <a:tab algn="l" pos="719280"/>
                          <a:tab algn="l" pos="1079640"/>
                          <a:tab algn="l" pos="1438200"/>
                          <a:tab algn="l" pos="1798560"/>
                          <a:tab algn="l" pos="2158920"/>
                          <a:tab algn="l" pos="2519280"/>
                          <a:tab algn="l" pos="2879640"/>
                          <a:tab algn="l" pos="3238560"/>
                          <a:tab algn="l" pos="3598920"/>
                          <a:tab algn="l" pos="3959280"/>
                          <a:tab algn="l" pos="431964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 </a:t>
                      </a:r>
                      <a:r>
                        <a:rPr b="0" lang="sv-S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-776 T: CGCGGAAGAGCC</a:t>
                      </a:r>
                      <a:r>
                        <a:rPr b="1" lang="sv-S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</a:t>
                      </a:r>
                      <a:r>
                        <a:rPr b="0" lang="sv-S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GGGAGAGCGTTGGT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676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358920"/>
                          <a:tab algn="l" pos="719280"/>
                          <a:tab algn="l" pos="1079640"/>
                          <a:tab algn="l" pos="1438200"/>
                          <a:tab algn="l" pos="1798560"/>
                          <a:tab algn="l" pos="2158920"/>
                          <a:tab algn="l" pos="2519280"/>
                          <a:tab algn="l" pos="2879640"/>
                          <a:tab algn="l" pos="3238560"/>
                          <a:tab algn="l" pos="3598920"/>
                          <a:tab algn="l" pos="3959280"/>
                          <a:tab algn="l" pos="431964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'PGL3 sequencing prim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358920"/>
                          <a:tab algn="l" pos="719280"/>
                          <a:tab algn="l" pos="1079640"/>
                          <a:tab algn="l" pos="1438200"/>
                          <a:tab algn="l" pos="1798560"/>
                          <a:tab algn="l" pos="2158920"/>
                          <a:tab algn="l" pos="2519280"/>
                          <a:tab algn="l" pos="2879640"/>
                          <a:tab algn="l" pos="3238560"/>
                          <a:tab algn="l" pos="3598920"/>
                          <a:tab algn="l" pos="3959280"/>
                          <a:tab algn="l" pos="431964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TAGCAAAATAGGCTGTCC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4440"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'PGL3 sequencing prim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TCAGCCTGCCTTTCCACTCT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50" name=""/>
          <p:cNvGraphicFramePr/>
          <p:nvPr/>
        </p:nvGraphicFramePr>
        <p:xfrm>
          <a:off x="81000" y="457200"/>
          <a:ext cx="6678720" cy="1467000"/>
        </p:xfrm>
        <a:graphic>
          <a:graphicData uri="http://schemas.openxmlformats.org/drawingml/2006/table">
            <a:tbl>
              <a:tblPr/>
              <a:tblGrid>
                <a:gridCol w="1128600"/>
                <a:gridCol w="730440"/>
                <a:gridCol w="620640"/>
                <a:gridCol w="2100240"/>
                <a:gridCol w="2098800"/>
              </a:tblGrid>
              <a:tr h="24444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equence (5' to 3'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4444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iRN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t No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ompany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en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ntisen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444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s_MyD88_10_HP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10310090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Qiagen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(UGA UUG CCU UAC AAA GUU)dTd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(UAA CUU UGU AAG GCA AUC A)dAd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4444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s_TICAM2_5HP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1026448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Qiagen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(GCC UGA GAU GAA ACA UAU A)dTd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(UAU AUG UUU CAU CUC AGG C)dAd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444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s_TRIF_5_HP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10016317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Qiagen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(CGG AAC AGA AAU UCU AUA A)dTd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(UUA  UAG AAU UUC UGU UCC G)dAd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480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LR4-HSS11081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62031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nvitrogen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UC UUU ACU AGC UCA UUC CUU ACC 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1" name="Rectangle 7"/>
          <p:cNvSpPr/>
          <p:nvPr/>
        </p:nvSpPr>
        <p:spPr>
          <a:xfrm>
            <a:off x="-27000" y="76320"/>
            <a:ext cx="6645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Supplemental Table S1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siRNA used for transfection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2" name=""/>
          <p:cNvGraphicFramePr/>
          <p:nvPr/>
        </p:nvGraphicFramePr>
        <p:xfrm>
          <a:off x="66600" y="2946240"/>
          <a:ext cx="6718320" cy="978120"/>
        </p:xfrm>
        <a:graphic>
          <a:graphicData uri="http://schemas.openxmlformats.org/drawingml/2006/table">
            <a:tbl>
              <a:tblPr/>
              <a:tblGrid>
                <a:gridCol w="960480"/>
                <a:gridCol w="2060640"/>
                <a:gridCol w="2109600"/>
                <a:gridCol w="1587600"/>
              </a:tblGrid>
              <a:tr h="24480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NP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rwar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ver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equencin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444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RF-3 amplification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TCAATTTGCATGTGACGCTCCCA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TTGCTCCACTTTCCCCAGAGTACA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4444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925 genotypin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CATAGGGGCGGGAACAG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GGGTAGCTCTCAAACTCGAGG –BIO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GTTTTATTTCAAGAAGTCG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444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776 genotypin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CGTAGGTAACGCGGAAGA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CTTTCCCCAGAGTACACAGC-BIO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AACGCGGAAGAGCC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3" name="Text Box 150"/>
          <p:cNvSpPr/>
          <p:nvPr/>
        </p:nvSpPr>
        <p:spPr>
          <a:xfrm>
            <a:off x="-27000" y="2362320"/>
            <a:ext cx="6858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Supplemental Table S2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Primers used for amplification and genotyping of the IRF3 promoter polymorphism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4" name=""/>
          <p:cNvGraphicFramePr/>
          <p:nvPr/>
        </p:nvGraphicFramePr>
        <p:xfrm>
          <a:off x="104760" y="723960"/>
          <a:ext cx="6600960" cy="1704960"/>
        </p:xfrm>
        <a:graphic>
          <a:graphicData uri="http://schemas.openxmlformats.org/drawingml/2006/table">
            <a:tbl>
              <a:tblPr/>
              <a:tblGrid>
                <a:gridCol w="1477800"/>
                <a:gridCol w="874800"/>
                <a:gridCol w="719280"/>
                <a:gridCol w="1008000"/>
                <a:gridCol w="792000"/>
                <a:gridCol w="720720"/>
                <a:gridCol w="1008360"/>
              </a:tblGrid>
              <a:tr h="23076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9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9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aediatric UTI patients and control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9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dult UTI patients and control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50436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9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9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inor allele frequenc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9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-valu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9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OR (95%CI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9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inor allele frequenc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9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-valu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9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OR (95%CI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yelonephritis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&lt;0.0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 (0.1-0.4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yelonephritis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 (0.1-0.6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135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6 (0.3-1.1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imary ABU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05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4 (0.8-2.5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ontrols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5" name="Text Box 437"/>
          <p:cNvSpPr/>
          <p:nvPr/>
        </p:nvSpPr>
        <p:spPr>
          <a:xfrm>
            <a:off x="66240" y="2460600"/>
            <a:ext cx="55191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*2x2 comparison by Fisher’s exact test between the primary ABU and the pyelonephritis group;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**2x2 comparison by Fisher’s exact test between patient group and control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57"/>
          <p:cNvSpPr/>
          <p:nvPr/>
        </p:nvSpPr>
        <p:spPr>
          <a:xfrm>
            <a:off x="-27000" y="103320"/>
            <a:ext cx="6716880" cy="46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Supplemental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able S4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inor allele frequencies of IRF3 promoter polymorphisms in UTI patient groups and healthy control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57"/>
          <p:cNvSpPr/>
          <p:nvPr/>
        </p:nvSpPr>
        <p:spPr>
          <a:xfrm>
            <a:off x="-27000" y="3335400"/>
            <a:ext cx="6716880" cy="46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Supplemental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able S5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rimers used for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reconstitution of a functional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pap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gene cluster in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E. coli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8397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8" name=""/>
          <p:cNvGraphicFramePr/>
          <p:nvPr/>
        </p:nvGraphicFramePr>
        <p:xfrm>
          <a:off x="66600" y="3944880"/>
          <a:ext cx="6248520" cy="1981080"/>
        </p:xfrm>
        <a:graphic>
          <a:graphicData uri="http://schemas.openxmlformats.org/drawingml/2006/table">
            <a:tbl>
              <a:tblPr/>
              <a:tblGrid>
                <a:gridCol w="1173240"/>
                <a:gridCol w="5075280"/>
              </a:tblGrid>
              <a:tr h="2689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358920"/>
                          <a:tab algn="l" pos="719280"/>
                          <a:tab algn="l" pos="1079640"/>
                          <a:tab algn="l" pos="1438200"/>
                          <a:tab algn="l" pos="1798560"/>
                          <a:tab algn="l" pos="2158920"/>
                          <a:tab algn="l" pos="2519280"/>
                          <a:tab algn="l" pos="2879640"/>
                          <a:tab algn="l" pos="3238560"/>
                          <a:tab algn="l" pos="3598920"/>
                          <a:tab algn="l" pos="3959280"/>
                          <a:tab algn="l" pos="431964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rimer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equence (5' to 3'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89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358920"/>
                          <a:tab algn="l" pos="719280"/>
                          <a:tab algn="l" pos="1079640"/>
                          <a:tab algn="l" pos="1438200"/>
                          <a:tab algn="l" pos="1798560"/>
                          <a:tab algn="l" pos="2158920"/>
                          <a:tab algn="l" pos="2519280"/>
                          <a:tab algn="l" pos="2879640"/>
                          <a:tab algn="l" pos="3238560"/>
                          <a:tab algn="l" pos="3598920"/>
                          <a:tab algn="l" pos="3959280"/>
                          <a:tab algn="l" pos="431964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S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358920"/>
                          <a:tab algn="l" pos="719280"/>
                          <a:tab algn="l" pos="1079640"/>
                          <a:tab algn="l" pos="1438200"/>
                          <a:tab algn="l" pos="1798560"/>
                          <a:tab algn="l" pos="2158920"/>
                          <a:tab algn="l" pos="2519280"/>
                          <a:tab algn="l" pos="2879640"/>
                          <a:tab algn="l" pos="3238560"/>
                          <a:tab algn="l" pos="3598920"/>
                          <a:tab algn="l" pos="3959280"/>
                          <a:tab algn="l" pos="431964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'-agtcatacctaaatgaataactgtaattacggaagtgatttctgatgaaagtgtaggctggagctgctt-3'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77280"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S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'-cttttgcctgaagctatccggcatactcaggcatttcacgctttatgacatatgaatatcctccttagttccta-3'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89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358920"/>
                          <a:tab algn="l" pos="719280"/>
                          <a:tab algn="l" pos="1079640"/>
                          <a:tab algn="l" pos="1438200"/>
                          <a:tab algn="l" pos="1798560"/>
                          <a:tab algn="l" pos="2158920"/>
                          <a:tab algn="l" pos="2519280"/>
                          <a:tab algn="l" pos="2879640"/>
                          <a:tab algn="l" pos="3238560"/>
                          <a:tab algn="l" pos="3598920"/>
                          <a:tab algn="l" pos="3959280"/>
                          <a:tab algn="l" pos="431964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KD3_papG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358920"/>
                          <a:tab algn="l" pos="719280"/>
                          <a:tab algn="l" pos="1079640"/>
                          <a:tab algn="l" pos="1438200"/>
                          <a:tab algn="l" pos="1798560"/>
                          <a:tab algn="l" pos="2158920"/>
                          <a:tab algn="l" pos="2519280"/>
                          <a:tab algn="l" pos="2879640"/>
                          <a:tab algn="l" pos="3238560"/>
                          <a:tab algn="l" pos="3598920"/>
                          <a:tab algn="l" pos="3959280"/>
                          <a:tab algn="l" pos="431964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'-cctttttgcgtggccagtgccaagcttgcatgcagattgcagcattacacatgaaaaaatggttcccagctttg-3'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424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358920"/>
                          <a:tab algn="l" pos="719280"/>
                          <a:tab algn="l" pos="1079640"/>
                          <a:tab algn="l" pos="1438200"/>
                          <a:tab algn="l" pos="1798560"/>
                          <a:tab algn="l" pos="2158920"/>
                          <a:tab algn="l" pos="2519280"/>
                          <a:tab algn="l" pos="2879640"/>
                          <a:tab algn="l" pos="3238560"/>
                          <a:tab algn="l" pos="3598920"/>
                          <a:tab algn="l" pos="3959280"/>
                          <a:tab algn="l" pos="431964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KD3_papX_rev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358920"/>
                          <a:tab algn="l" pos="719280"/>
                          <a:tab algn="l" pos="1079640"/>
                          <a:tab algn="l" pos="1438200"/>
                          <a:tab algn="l" pos="1798560"/>
                          <a:tab algn="l" pos="2158920"/>
                          <a:tab algn="l" pos="2519280"/>
                          <a:tab algn="l" pos="2879640"/>
                          <a:tab algn="l" pos="3238560"/>
                          <a:tab algn="l" pos="3598920"/>
                          <a:tab algn="l" pos="3959280"/>
                          <a:tab algn="l" pos="431964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'-gaaagtataggaacttcgaagcagctccagcctacacaatcgctcaagacactttatgagctgacatcatcaag-3'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89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358920"/>
                          <a:tab algn="l" pos="719280"/>
                          <a:tab algn="l" pos="1079640"/>
                          <a:tab algn="l" pos="1438200"/>
                          <a:tab algn="l" pos="1798560"/>
                          <a:tab algn="l" pos="2158920"/>
                          <a:tab algn="l" pos="2519280"/>
                          <a:tab algn="l" pos="2879640"/>
                          <a:tab algn="l" pos="3238560"/>
                          <a:tab algn="l" pos="3598920"/>
                          <a:tab algn="l" pos="3959280"/>
                          <a:tab algn="l" pos="431964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358920"/>
                          <a:tab algn="l" pos="719280"/>
                          <a:tab algn="l" pos="1079640"/>
                          <a:tab algn="l" pos="1438200"/>
                          <a:tab algn="l" pos="1798560"/>
                          <a:tab algn="l" pos="2158920"/>
                          <a:tab algn="l" pos="2519280"/>
                          <a:tab algn="l" pos="2879640"/>
                          <a:tab algn="l" pos="3238560"/>
                          <a:tab algn="l" pos="3598920"/>
                          <a:tab algn="l" pos="3959280"/>
                          <a:tab algn="l" pos="431964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'-gtcatacccaaatgaataactgtaattacggaagtgatttctgatgaaaaaatggttcccagctttgtta-3'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388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358920"/>
                          <a:tab algn="l" pos="719280"/>
                          <a:tab algn="l" pos="1079640"/>
                          <a:tab algn="l" pos="1438200"/>
                          <a:tab algn="l" pos="1798560"/>
                          <a:tab algn="l" pos="2158920"/>
                          <a:tab algn="l" pos="2519280"/>
                          <a:tab algn="l" pos="2879640"/>
                          <a:tab algn="l" pos="3238560"/>
                          <a:tab algn="l" pos="3598920"/>
                          <a:tab algn="l" pos="3959280"/>
                          <a:tab algn="l" pos="431964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14b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358920"/>
                          <a:tab algn="l" pos="719280"/>
                          <a:tab algn="l" pos="1079640"/>
                          <a:tab algn="l" pos="1438200"/>
                          <a:tab algn="l" pos="1798560"/>
                          <a:tab algn="l" pos="2158920"/>
                          <a:tab algn="l" pos="2519280"/>
                          <a:tab algn="l" pos="2879640"/>
                          <a:tab algn="l" pos="3238560"/>
                          <a:tab algn="l" pos="3598920"/>
                          <a:tab algn="l" pos="3959280"/>
                          <a:tab algn="l" pos="431964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'-ttcttttgcctgaagctatccggcatactcaggcatttcacgcttcatggtccatatgaatatcctccttagttcc-3'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51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8-27T12:29:19Z</dcterms:created>
  <dc:creator>Nataliya Lutay</dc:creator>
  <dc:description/>
  <dc:language>en-US</dc:language>
  <cp:lastModifiedBy>Bryndís</cp:lastModifiedBy>
  <dcterms:modified xsi:type="dcterms:W3CDTF">2010-06-13T16:16:29Z</dcterms:modified>
  <cp:revision>1996</cp:revision>
  <dc:subject/>
  <dc:title>Slide 1</dc:title>
</cp:coreProperties>
</file>